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8AA3BC0C-2EA0-493D-A524-6C2488B8CD38}"/>
    <pc:docChg chg="custSel delSld modSld">
      <pc:chgData name="Mireille Vankemmelbeke" userId="e2496c92-8ae2-4817-81db-1e2fdf7923b3" providerId="ADAL" clId="{8AA3BC0C-2EA0-493D-A524-6C2488B8CD38}" dt="2024-06-21T15:50:57.942" v="4" actId="1076"/>
      <pc:docMkLst>
        <pc:docMk/>
      </pc:docMkLst>
      <pc:sldChg chg="del">
        <pc:chgData name="Mireille Vankemmelbeke" userId="e2496c92-8ae2-4817-81db-1e2fdf7923b3" providerId="ADAL" clId="{8AA3BC0C-2EA0-493D-A524-6C2488B8CD38}" dt="2024-06-21T15:50:41.717" v="0" actId="47"/>
        <pc:sldMkLst>
          <pc:docMk/>
          <pc:sldMk cId="3935331238" sldId="268"/>
        </pc:sldMkLst>
      </pc:sldChg>
      <pc:sldChg chg="del">
        <pc:chgData name="Mireille Vankemmelbeke" userId="e2496c92-8ae2-4817-81db-1e2fdf7923b3" providerId="ADAL" clId="{8AA3BC0C-2EA0-493D-A524-6C2488B8CD38}" dt="2024-06-21T15:50:42.913" v="1" actId="47"/>
        <pc:sldMkLst>
          <pc:docMk/>
          <pc:sldMk cId="868960993" sldId="269"/>
        </pc:sldMkLst>
      </pc:sldChg>
      <pc:sldChg chg="delSp modSp mod">
        <pc:chgData name="Mireille Vankemmelbeke" userId="e2496c92-8ae2-4817-81db-1e2fdf7923b3" providerId="ADAL" clId="{8AA3BC0C-2EA0-493D-A524-6C2488B8CD38}" dt="2024-06-21T15:50:57.942" v="4" actId="1076"/>
        <pc:sldMkLst>
          <pc:docMk/>
          <pc:sldMk cId="2268793920" sldId="270"/>
        </pc:sldMkLst>
        <pc:spChg chg="del">
          <ac:chgData name="Mireille Vankemmelbeke" userId="e2496c92-8ae2-4817-81db-1e2fdf7923b3" providerId="ADAL" clId="{8AA3BC0C-2EA0-493D-A524-6C2488B8CD38}" dt="2024-06-21T15:50:51.082" v="2" actId="478"/>
          <ac:spMkLst>
            <pc:docMk/>
            <pc:sldMk cId="2268793920" sldId="270"/>
            <ac:spMk id="3" creationId="{411201C2-C076-747D-F08A-A44B40E18A6D}"/>
          </ac:spMkLst>
        </pc:spChg>
        <pc:spChg chg="del">
          <ac:chgData name="Mireille Vankemmelbeke" userId="e2496c92-8ae2-4817-81db-1e2fdf7923b3" providerId="ADAL" clId="{8AA3BC0C-2EA0-493D-A524-6C2488B8CD38}" dt="2024-06-21T15:50:51.082" v="2" actId="478"/>
          <ac:spMkLst>
            <pc:docMk/>
            <pc:sldMk cId="2268793920" sldId="270"/>
            <ac:spMk id="4" creationId="{6C679A7D-5300-C36C-0199-33B42D6BEBE0}"/>
          </ac:spMkLst>
        </pc:spChg>
        <pc:spChg chg="del">
          <ac:chgData name="Mireille Vankemmelbeke" userId="e2496c92-8ae2-4817-81db-1e2fdf7923b3" providerId="ADAL" clId="{8AA3BC0C-2EA0-493D-A524-6C2488B8CD38}" dt="2024-06-21T15:50:51.082" v="2" actId="478"/>
          <ac:spMkLst>
            <pc:docMk/>
            <pc:sldMk cId="2268793920" sldId="270"/>
            <ac:spMk id="5" creationId="{6BAD10FA-2C98-A648-CA57-E529F81BBA0C}"/>
          </ac:spMkLst>
        </pc:spChg>
        <pc:spChg chg="del">
          <ac:chgData name="Mireille Vankemmelbeke" userId="e2496c92-8ae2-4817-81db-1e2fdf7923b3" providerId="ADAL" clId="{8AA3BC0C-2EA0-493D-A524-6C2488B8CD38}" dt="2024-06-21T15:50:51.082" v="2" actId="478"/>
          <ac:spMkLst>
            <pc:docMk/>
            <pc:sldMk cId="2268793920" sldId="270"/>
            <ac:spMk id="8" creationId="{388F4722-3142-0E4E-7B51-C1AD4808FA62}"/>
          </ac:spMkLst>
        </pc:spChg>
        <pc:spChg chg="del">
          <ac:chgData name="Mireille Vankemmelbeke" userId="e2496c92-8ae2-4817-81db-1e2fdf7923b3" providerId="ADAL" clId="{8AA3BC0C-2EA0-493D-A524-6C2488B8CD38}" dt="2024-06-21T15:50:51.082" v="2" actId="478"/>
          <ac:spMkLst>
            <pc:docMk/>
            <pc:sldMk cId="2268793920" sldId="270"/>
            <ac:spMk id="9" creationId="{76577009-EBC2-0F5C-D361-900F07FE541F}"/>
          </ac:spMkLst>
        </pc:spChg>
        <pc:spChg chg="mod">
          <ac:chgData name="Mireille Vankemmelbeke" userId="e2496c92-8ae2-4817-81db-1e2fdf7923b3" providerId="ADAL" clId="{8AA3BC0C-2EA0-493D-A524-6C2488B8CD38}" dt="2024-06-21T15:50:57.942" v="4" actId="1076"/>
          <ac:spMkLst>
            <pc:docMk/>
            <pc:sldMk cId="2268793920" sldId="270"/>
            <ac:spMk id="19" creationId="{48315DE5-A130-0BA2-72C1-0450A2A5CF23}"/>
          </ac:spMkLst>
        </pc:spChg>
        <pc:picChg chg="del">
          <ac:chgData name="Mireille Vankemmelbeke" userId="e2496c92-8ae2-4817-81db-1e2fdf7923b3" providerId="ADAL" clId="{8AA3BC0C-2EA0-493D-A524-6C2488B8CD38}" dt="2024-06-21T15:50:51.082" v="2" actId="478"/>
          <ac:picMkLst>
            <pc:docMk/>
            <pc:sldMk cId="2268793920" sldId="270"/>
            <ac:picMk id="2" creationId="{43C713C9-25BA-E672-0179-9E620305EF59}"/>
          </ac:picMkLst>
        </pc:picChg>
        <pc:picChg chg="del">
          <ac:chgData name="Mireille Vankemmelbeke" userId="e2496c92-8ae2-4817-81db-1e2fdf7923b3" providerId="ADAL" clId="{8AA3BC0C-2EA0-493D-A524-6C2488B8CD38}" dt="2024-06-21T15:50:51.082" v="2" actId="478"/>
          <ac:picMkLst>
            <pc:docMk/>
            <pc:sldMk cId="2268793920" sldId="270"/>
            <ac:picMk id="6" creationId="{620BD82B-C7FC-6143-EE6F-A2BE66DCBC12}"/>
          </ac:picMkLst>
        </pc:picChg>
        <pc:picChg chg="del">
          <ac:chgData name="Mireille Vankemmelbeke" userId="e2496c92-8ae2-4817-81db-1e2fdf7923b3" providerId="ADAL" clId="{8AA3BC0C-2EA0-493D-A524-6C2488B8CD38}" dt="2024-06-21T15:50:51.082" v="2" actId="478"/>
          <ac:picMkLst>
            <pc:docMk/>
            <pc:sldMk cId="2268793920" sldId="270"/>
            <ac:picMk id="10" creationId="{295FA8D2-E6CA-5C56-0855-D3C356A539B3}"/>
          </ac:picMkLst>
        </pc:picChg>
        <pc:picChg chg="del">
          <ac:chgData name="Mireille Vankemmelbeke" userId="e2496c92-8ae2-4817-81db-1e2fdf7923b3" providerId="ADAL" clId="{8AA3BC0C-2EA0-493D-A524-6C2488B8CD38}" dt="2024-06-21T15:50:51.082" v="2" actId="478"/>
          <ac:picMkLst>
            <pc:docMk/>
            <pc:sldMk cId="2268793920" sldId="270"/>
            <ac:picMk id="12" creationId="{B54F9ADC-933E-3BD5-B1CF-8E6048D4D8E2}"/>
          </ac:picMkLst>
        </pc:picChg>
        <pc:picChg chg="del">
          <ac:chgData name="Mireille Vankemmelbeke" userId="e2496c92-8ae2-4817-81db-1e2fdf7923b3" providerId="ADAL" clId="{8AA3BC0C-2EA0-493D-A524-6C2488B8CD38}" dt="2024-06-21T15:50:51.082" v="2" actId="478"/>
          <ac:picMkLst>
            <pc:docMk/>
            <pc:sldMk cId="2268793920" sldId="270"/>
            <ac:picMk id="13" creationId="{24512802-B1EB-520D-C5F5-52F1ED5766AA}"/>
          </ac:picMkLst>
        </pc:picChg>
        <pc:picChg chg="mod">
          <ac:chgData name="Mireille Vankemmelbeke" userId="e2496c92-8ae2-4817-81db-1e2fdf7923b3" providerId="ADAL" clId="{8AA3BC0C-2EA0-493D-A524-6C2488B8CD38}" dt="2024-06-21T15:50:57.942" v="4" actId="1076"/>
          <ac:picMkLst>
            <pc:docMk/>
            <pc:sldMk cId="2268793920" sldId="270"/>
            <ac:picMk id="21" creationId="{F3403A0F-5911-E5E8-5A09-51B2AAF48C9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34F97C-AF6A-4678-A188-E641391358E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972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>
            <a:extLst>
              <a:ext uri="{FF2B5EF4-FFF2-40B4-BE49-F238E27FC236}">
                <a16:creationId xmlns:a16="http://schemas.microsoft.com/office/drawing/2014/main" id="{1061DE32-896F-447B-5DEA-ACB36D3C14CF}"/>
              </a:ext>
            </a:extLst>
          </p:cNvPr>
          <p:cNvSpPr txBox="1">
            <a:spLocks/>
          </p:cNvSpPr>
          <p:nvPr/>
        </p:nvSpPr>
        <p:spPr>
          <a:xfrm>
            <a:off x="30481" y="22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sp>
        <p:nvSpPr>
          <p:cNvPr id="19" name="TextBox 1">
            <a:extLst>
              <a:ext uri="{FF2B5EF4-FFF2-40B4-BE49-F238E27FC236}">
                <a16:creationId xmlns:a16="http://schemas.microsoft.com/office/drawing/2014/main" id="{48315DE5-A130-0BA2-72C1-0450A2A5CF23}"/>
              </a:ext>
            </a:extLst>
          </p:cNvPr>
          <p:cNvSpPr txBox="1"/>
          <p:nvPr/>
        </p:nvSpPr>
        <p:spPr>
          <a:xfrm>
            <a:off x="0" y="958377"/>
            <a:ext cx="7070122" cy="2308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/>
              <a:t>Supplemental Figure 11</a:t>
            </a:r>
            <a:r>
              <a:rPr lang="en-GB" sz="900" dirty="0"/>
              <a:t>. Individual tumour growth curves from anti-tumour study testing efficacy of different SC134-TCB dosing regimen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F3403A0F-5911-E5E8-5A09-51B2AAF48C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3940" y="1297620"/>
            <a:ext cx="4152899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879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50:59Z</dcterms:modified>
</cp:coreProperties>
</file>